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75" r:id="rId2"/>
    <p:sldId id="280" r:id="rId3"/>
    <p:sldId id="266" r:id="rId4"/>
    <p:sldId id="267" r:id="rId5"/>
    <p:sldId id="277" r:id="rId6"/>
    <p:sldId id="272" r:id="rId7"/>
    <p:sldId id="279" r:id="rId8"/>
  </p:sldIdLst>
  <p:sldSz cx="12192000" cy="6858000"/>
  <p:notesSz cx="6724650" cy="97742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3" autoAdjust="0"/>
    <p:restoredTop sz="92508" autoAdjust="0"/>
  </p:normalViewPr>
  <p:slideViewPr>
    <p:cSldViewPr snapToGrid="0">
      <p:cViewPr varScale="1">
        <p:scale>
          <a:sx n="75" d="100"/>
          <a:sy n="75" d="100"/>
        </p:scale>
        <p:origin x="32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4791" cy="490186"/>
          </a:xfrm>
          <a:prstGeom prst="rect">
            <a:avLst/>
          </a:prstGeom>
        </p:spPr>
        <p:txBody>
          <a:bodyPr vert="horz" lIns="89346" tIns="44673" rIns="89346" bIns="4467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08308" y="0"/>
            <a:ext cx="2914790" cy="490186"/>
          </a:xfrm>
          <a:prstGeom prst="rect">
            <a:avLst/>
          </a:prstGeom>
        </p:spPr>
        <p:txBody>
          <a:bodyPr vert="horz" lIns="89346" tIns="44673" rIns="89346" bIns="44673" rtlCol="0"/>
          <a:lstStyle>
            <a:lvl1pPr algn="r">
              <a:defRPr sz="1200"/>
            </a:lvl1pPr>
          </a:lstStyle>
          <a:p>
            <a:fld id="{2D78B8C6-D138-4FBC-832E-88A2D1B0E334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33388" y="1222375"/>
            <a:ext cx="5859462" cy="32972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9346" tIns="44673" rIns="89346" bIns="4467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3240" y="4703299"/>
            <a:ext cx="5379720" cy="3848577"/>
          </a:xfrm>
          <a:prstGeom prst="rect">
            <a:avLst/>
          </a:prstGeom>
        </p:spPr>
        <p:txBody>
          <a:bodyPr vert="horz" lIns="89346" tIns="44673" rIns="89346" bIns="44673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284052"/>
            <a:ext cx="2914791" cy="490186"/>
          </a:xfrm>
          <a:prstGeom prst="rect">
            <a:avLst/>
          </a:prstGeom>
        </p:spPr>
        <p:txBody>
          <a:bodyPr vert="horz" lIns="89346" tIns="44673" rIns="89346" bIns="4467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08308" y="9284052"/>
            <a:ext cx="2914790" cy="490186"/>
          </a:xfrm>
          <a:prstGeom prst="rect">
            <a:avLst/>
          </a:prstGeom>
        </p:spPr>
        <p:txBody>
          <a:bodyPr vert="horz" lIns="89346" tIns="44673" rIns="89346" bIns="44673" rtlCol="0" anchor="b"/>
          <a:lstStyle>
            <a:lvl1pPr algn="r">
              <a:defRPr sz="1200"/>
            </a:lvl1pPr>
          </a:lstStyle>
          <a:p>
            <a:fld id="{3C868FED-1A41-4FC5-914D-E72594767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1917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C868FED-1A41-4FC5-914D-E7259476740A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1862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3B92C-EAEC-4E01-A1CA-40534867ACD5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987B4-EDD0-4C93-B4ED-BC637E7C33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590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3B92C-EAEC-4E01-A1CA-40534867ACD5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987B4-EDD0-4C93-B4ED-BC637E7C33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73491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3B92C-EAEC-4E01-A1CA-40534867ACD5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987B4-EDD0-4C93-B4ED-BC637E7C33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40353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3B92C-EAEC-4E01-A1CA-40534867ACD5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987B4-EDD0-4C93-B4ED-BC637E7C33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316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3B92C-EAEC-4E01-A1CA-40534867ACD5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987B4-EDD0-4C93-B4ED-BC637E7C33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4708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3B92C-EAEC-4E01-A1CA-40534867ACD5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987B4-EDD0-4C93-B4ED-BC637E7C33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9262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3B92C-EAEC-4E01-A1CA-40534867ACD5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987B4-EDD0-4C93-B4ED-BC637E7C33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8118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3B92C-EAEC-4E01-A1CA-40534867ACD5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987B4-EDD0-4C93-B4ED-BC637E7C33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12437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3B92C-EAEC-4E01-A1CA-40534867ACD5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987B4-EDD0-4C93-B4ED-BC637E7C33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039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3B92C-EAEC-4E01-A1CA-40534867ACD5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987B4-EDD0-4C93-B4ED-BC637E7C33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4929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3B92C-EAEC-4E01-A1CA-40534867ACD5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8987B4-EDD0-4C93-B4ED-BC637E7C33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8141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3B92C-EAEC-4E01-A1CA-40534867ACD5}" type="datetimeFigureOut">
              <a:rPr lang="en-US" smtClean="0"/>
              <a:t>7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8987B4-EDD0-4C93-B4ED-BC637E7C33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4756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757646" y="1028700"/>
            <a:ext cx="10773953" cy="5509200"/>
          </a:xfrm>
          <a:prstGeom prst="rect">
            <a:avLst/>
          </a:prstGeom>
          <a:noFill/>
          <a:ln>
            <a:solidFill>
              <a:srgbClr val="FFFF00"/>
            </a:solidFill>
          </a:ln>
        </p:spPr>
        <p:txBody>
          <a:bodyPr wrap="square">
            <a:spAutoFit/>
          </a:bodyPr>
          <a:lstStyle/>
          <a:p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 </a:t>
            </a:r>
          </a:p>
          <a:p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IDENCE, MORTALITY AND SURVIVAL IN MULTIPLE MYELOMA COMPARED TO OTHER HEMATOPOIETIC NEOPLASMS IN SWEDEN UP TO YEAR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16</a:t>
            </a: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Kari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mminki,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ta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örsti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arkus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ansson</a:t>
            </a: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ST OF MATERIAL</a:t>
            </a:r>
          </a:p>
          <a:p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de-DE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. Age-standardized mortality and estimated annual percent change in MM in age groups.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dirty="0"/>
              <a:t>Relative 1-year and 5-year survival rates for MM </a:t>
            </a:r>
            <a:r>
              <a:rPr lang="en-US" dirty="0" smtClean="0"/>
              <a:t>in men and women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 </a:t>
            </a:r>
            <a:r>
              <a:rPr lang="en-US" dirty="0"/>
              <a:t>Relative 1-year and 5-year survival rates for </a:t>
            </a:r>
            <a:r>
              <a:rPr lang="en-US" dirty="0" smtClean="0"/>
              <a:t>hematopoietic neoplasms </a:t>
            </a:r>
            <a:r>
              <a:rPr lang="en-US" dirty="0"/>
              <a:t>in men and </a:t>
            </a:r>
            <a:r>
              <a:rPr lang="en-US" dirty="0" smtClean="0"/>
              <a:t>women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3. The 1- and</a:t>
            </a:r>
            <a:r>
              <a:rPr lang="en-US" dirty="0" smtClean="0"/>
              <a:t> </a:t>
            </a:r>
            <a:r>
              <a:rPr lang="en-US" dirty="0"/>
              <a:t>5-year relative survival </a:t>
            </a:r>
            <a:r>
              <a:rPr lang="en-US" dirty="0" smtClean="0"/>
              <a:t>for all </a:t>
            </a:r>
            <a:r>
              <a:rPr lang="en-US" dirty="0"/>
              <a:t>hematopoietic neoplasms </a:t>
            </a:r>
            <a:r>
              <a:rPr lang="en-US" dirty="0" smtClean="0"/>
              <a:t>and MM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. 5-year survival for </a:t>
            </a:r>
            <a:r>
              <a:rPr lang="en-US" dirty="0" smtClean="0"/>
              <a:t>the </a:t>
            </a:r>
            <a:r>
              <a:rPr lang="en-US" dirty="0"/>
              <a:t>main </a:t>
            </a:r>
            <a:r>
              <a:rPr lang="en-US" dirty="0" smtClean="0"/>
              <a:t>subtypes of hematopoietic neoplasms.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. Proportions of MM and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symptomatic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M (smoldering MM, SMM) in the Swedish Myeloma Registry. The curves in the bottom include rare disease types of plasma cell leukemia, solitary bone and extramedullary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smacytoma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dirty="0" smtClean="0"/>
              <a:t>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09575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99382910"/>
              </p:ext>
            </p:extLst>
          </p:nvPr>
        </p:nvGraphicFramePr>
        <p:xfrm>
          <a:off x="1253067" y="635001"/>
          <a:ext cx="8869680" cy="5977468"/>
        </p:xfrm>
        <a:graphic>
          <a:graphicData uri="http://schemas.openxmlformats.org/drawingml/2006/table">
            <a:tbl>
              <a:tblPr firstRow="1" firstCol="1" bandRow="1"/>
              <a:tblGrid>
                <a:gridCol w="2191855"/>
                <a:gridCol w="2420495"/>
                <a:gridCol w="1955497"/>
                <a:gridCol w="2301833"/>
              </a:tblGrid>
              <a:tr h="108456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SUPPLEMENTARY TABLE 1. Age standardized mortality rates (MR)/100,000 and estimated annual percent changes (EAPC) for men and women 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in </a:t>
                      </a: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age </a:t>
                      </a:r>
                      <a:r>
                        <a:rPr lang="en-US" sz="120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groups in 1967-2016.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38424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PERIOD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45720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MEN 0-69  y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MEN 70-79 y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45720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MEN 80-85+  y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8424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45720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45720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45720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73440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967-2016 (N) MR (SE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(3888)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</a:t>
                      </a: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.3 (0.02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(4077) 26.0 (0.41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(3240)</a:t>
                      </a:r>
                      <a:r>
                        <a:rPr lang="en-US" sz="12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 </a:t>
                      </a: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49.2 (0.88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8424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EAPC </a:t>
                      </a: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[95%CI]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-0.95 [-1.20;-0.70]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-0.53 [-0.76;-0.29]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0.52 [0.14;0.91]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8424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8424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PERIOD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45720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WOMEN 0-69  y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WOMEN 70-79 y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WOMEN 80-85+  y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8424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45720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45720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45720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 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73440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1967-2016 (N) MR (SE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(2764) 0.9 (0.02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(3563) 18.4 (0.32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(3723) 31.9 (0.52)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384243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EAPC </a:t>
                      </a: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[95%CI]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-1.09 [-1.40;-0.78]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-0.37 [-0.59;-0.15]</a:t>
                      </a:r>
                      <a:endParaRPr lang="en-US" sz="1200" b="1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0.13 [-0.17;0.43]</a:t>
                      </a:r>
                      <a:endParaRPr lang="en-US" sz="12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734402">
                <a:tc gridSpan="4"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Abbreviations: MR mortality rate, SE standard error, EAPC estimated annual percent change</a:t>
                      </a:r>
                      <a:r>
                        <a:rPr lang="en-US" sz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</a:rPr>
                        <a:t>. Bolding indicates that 95%CI does not include 0.00.</a:t>
                      </a: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algn="l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endParaRPr lang="en-US" sz="12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</a:endParaRPr>
                    </a:p>
                  </a:txBody>
                  <a:tcPr marL="9525" marR="9525" marT="9525" marB="9525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910006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5441" y="175364"/>
            <a:ext cx="8342334" cy="655111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254343" y="1593669"/>
            <a:ext cx="13454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err="1" smtClean="0"/>
              <a:t>SFig</a:t>
            </a:r>
            <a:r>
              <a:rPr lang="en-US" sz="2400" dirty="0" smtClean="0"/>
              <a:t>. 1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1042717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4608" y="225469"/>
            <a:ext cx="9983244" cy="674207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997852" y="2259874"/>
            <a:ext cx="11941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err="1" smtClean="0"/>
              <a:t>SFig</a:t>
            </a:r>
            <a:r>
              <a:rPr lang="en-US" sz="2400" dirty="0" smtClean="0"/>
              <a:t>. 2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8192075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3547" y="-151922"/>
            <a:ext cx="9202453" cy="690184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9906000" y="1058091"/>
            <a:ext cx="183750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err="1" smtClean="0"/>
              <a:t>SFig</a:t>
            </a:r>
            <a:r>
              <a:rPr lang="en-US" sz="2800" dirty="0" smtClean="0"/>
              <a:t>. 3 </a:t>
            </a:r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34231690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6" t="9592" r="3547" b="3045"/>
          <a:stretch/>
        </p:blipFill>
        <p:spPr>
          <a:xfrm>
            <a:off x="1166230" y="209007"/>
            <a:ext cx="9242626" cy="629840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0567851" y="1397725"/>
            <a:ext cx="16241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 err="1" smtClean="0"/>
              <a:t>SFig</a:t>
            </a:r>
            <a:r>
              <a:rPr lang="en-US" sz="2400" dirty="0" smtClean="0"/>
              <a:t>. 4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1656791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l="6049" t="5263" r="-114" b="5457"/>
          <a:stretch/>
        </p:blipFill>
        <p:spPr>
          <a:xfrm>
            <a:off x="1786468" y="922351"/>
            <a:ext cx="6680200" cy="559374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9355667" y="2302933"/>
            <a:ext cx="15663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SFig</a:t>
            </a:r>
            <a:r>
              <a:rPr lang="en-US" dirty="0"/>
              <a:t>. </a:t>
            </a:r>
            <a:r>
              <a:rPr lang="en-US" dirty="0" smtClean="0"/>
              <a:t>5</a:t>
            </a:r>
            <a:endParaRPr lang="en-US" dirty="0"/>
          </a:p>
          <a:p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4800600" y="1930400"/>
            <a:ext cx="8212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smtClean="0"/>
              <a:t>MM</a:t>
            </a:r>
            <a:endParaRPr lang="en-US" b="1" dirty="0"/>
          </a:p>
        </p:txBody>
      </p:sp>
      <p:sp>
        <p:nvSpPr>
          <p:cNvPr id="7" name="TextBox 6"/>
          <p:cNvSpPr txBox="1"/>
          <p:nvPr/>
        </p:nvSpPr>
        <p:spPr>
          <a:xfrm>
            <a:off x="5046133" y="4572000"/>
            <a:ext cx="11599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MM</a:t>
            </a:r>
            <a:endParaRPr lang="en-US" b="1" dirty="0"/>
          </a:p>
          <a:p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1667933" y="2480733"/>
            <a:ext cx="39793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 smtClean="0"/>
              <a:t>%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33902716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4</TotalTime>
  <Words>355</Words>
  <Application>Microsoft Office PowerPoint</Application>
  <PresentationFormat>Widescreen</PresentationFormat>
  <Paragraphs>62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DKFZ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mminki, Kari</dc:creator>
  <cp:lastModifiedBy>Hemminki, Kari</cp:lastModifiedBy>
  <cp:revision>43</cp:revision>
  <cp:lastPrinted>2021-07-08T09:02:10Z</cp:lastPrinted>
  <dcterms:created xsi:type="dcterms:W3CDTF">2020-11-18T11:14:54Z</dcterms:created>
  <dcterms:modified xsi:type="dcterms:W3CDTF">2021-07-08T09:05:03Z</dcterms:modified>
</cp:coreProperties>
</file>